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47" autoAdjust="0"/>
    <p:restoredTop sz="94660"/>
  </p:normalViewPr>
  <p:slideViewPr>
    <p:cSldViewPr snapToGrid="0">
      <p:cViewPr varScale="1">
        <p:scale>
          <a:sx n="53" d="100"/>
          <a:sy n="53" d="100"/>
        </p:scale>
        <p:origin x="53" y="81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om du vill redigera mall för underrubrikformat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94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205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740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212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073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510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627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45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266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563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962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99750-C2FB-471C-8BED-8E315E080968}" type="datetimeFigureOut">
              <a:rPr lang="en-US" smtClean="0"/>
              <a:t>9/9/2023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255E2-D36E-4F3E-9112-3AF3F594BA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101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3676" y="1913334"/>
            <a:ext cx="4639355" cy="2735751"/>
          </a:xfrm>
          <a:prstGeom prst="rect">
            <a:avLst/>
          </a:prstGeom>
        </p:spPr>
      </p:pic>
      <p:sp>
        <p:nvSpPr>
          <p:cNvPr id="8" name="textruta 7"/>
          <p:cNvSpPr txBox="1"/>
          <p:nvPr/>
        </p:nvSpPr>
        <p:spPr>
          <a:xfrm>
            <a:off x="268585" y="282760"/>
            <a:ext cx="32459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ruta 8"/>
          <p:cNvSpPr txBox="1"/>
          <p:nvPr/>
        </p:nvSpPr>
        <p:spPr>
          <a:xfrm>
            <a:off x="1565005" y="1346678"/>
            <a:ext cx="740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ruta 9"/>
          <p:cNvSpPr txBox="1"/>
          <p:nvPr/>
        </p:nvSpPr>
        <p:spPr>
          <a:xfrm>
            <a:off x="6822804" y="1346678"/>
            <a:ext cx="740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ruta 10"/>
          <p:cNvSpPr txBox="1"/>
          <p:nvPr/>
        </p:nvSpPr>
        <p:spPr>
          <a:xfrm rot="10800000">
            <a:off x="6294507" y="1575283"/>
            <a:ext cx="400110" cy="2841343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AF(%)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ruta 15"/>
          <p:cNvSpPr txBox="1"/>
          <p:nvPr/>
        </p:nvSpPr>
        <p:spPr>
          <a:xfrm>
            <a:off x="7139100" y="4277499"/>
            <a:ext cx="1824612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gative (plasma)</a:t>
            </a:r>
            <a:b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17" name="textruta 16"/>
          <p:cNvSpPr txBox="1"/>
          <p:nvPr/>
        </p:nvSpPr>
        <p:spPr>
          <a:xfrm>
            <a:off x="9038146" y="4277499"/>
            <a:ext cx="1831209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(plasma)</a:t>
            </a:r>
            <a:b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25" name="textruta 24"/>
          <p:cNvSpPr txBox="1"/>
          <p:nvPr/>
        </p:nvSpPr>
        <p:spPr>
          <a:xfrm>
            <a:off x="1526307" y="4975714"/>
            <a:ext cx="95009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AF of each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specific genetic variant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etermined by NGS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cells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d VAF of each variant in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 in relation to results of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DNA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plasma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F of each genetic varian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termin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ll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as observed to follow the same trend as VA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termined by NGS gene panel on sam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specific genetic variants detected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fDN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rom plasma had higher median VAF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ells than undetectable variants in plasma. </a:t>
            </a:r>
          </a:p>
        </p:txBody>
      </p:sp>
      <p:pic>
        <p:nvPicPr>
          <p:cNvPr id="2" name="Bildobjekt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1875" y="1631728"/>
            <a:ext cx="5243076" cy="33129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17606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111</Words>
  <Application>Microsoft Office PowerPoint</Application>
  <PresentationFormat>Bredbild</PresentationFormat>
  <Paragraphs>7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Ninni Mu</dc:creator>
  <cp:lastModifiedBy>Ninni Mu</cp:lastModifiedBy>
  <cp:revision>23</cp:revision>
  <dcterms:created xsi:type="dcterms:W3CDTF">2023-03-08T21:09:13Z</dcterms:created>
  <dcterms:modified xsi:type="dcterms:W3CDTF">2023-09-09T16:30:32Z</dcterms:modified>
</cp:coreProperties>
</file>